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1" autoAdjust="0"/>
    <p:restoredTop sz="94660"/>
  </p:normalViewPr>
  <p:slideViewPr>
    <p:cSldViewPr snapToGrid="0">
      <p:cViewPr varScale="1">
        <p:scale>
          <a:sx n="42" d="100"/>
          <a:sy n="42" d="100"/>
        </p:scale>
        <p:origin x="214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6962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931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2406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8265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007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250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5370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5143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635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8667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41CCE-7856-4C00-88C3-A7A83D8F5243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2080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641CCE-7856-4C00-88C3-A7A83D8F5243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8230D-2A15-4976-A18D-2B5B9145BC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636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2935DD3-DDC2-1F4D-AF92-802F229C1158}"/>
              </a:ext>
            </a:extLst>
          </p:cNvPr>
          <p:cNvSpPr txBox="1"/>
          <p:nvPr/>
        </p:nvSpPr>
        <p:spPr>
          <a:xfrm>
            <a:off x="2362200" y="86413"/>
            <a:ext cx="4430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.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suruda T, et al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A1FAC03F-029D-2A04-1851-5E4C296619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7005184"/>
              </p:ext>
            </p:extLst>
          </p:nvPr>
        </p:nvGraphicFramePr>
        <p:xfrm>
          <a:off x="317740" y="1036016"/>
          <a:ext cx="6349016" cy="787132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79578">
                  <a:extLst>
                    <a:ext uri="{9D8B030D-6E8A-4147-A177-3AD203B41FA5}">
                      <a16:colId xmlns:a16="http://schemas.microsoft.com/office/drawing/2014/main" val="2333650887"/>
                    </a:ext>
                  </a:extLst>
                </a:gridCol>
                <a:gridCol w="561788">
                  <a:extLst>
                    <a:ext uri="{9D8B030D-6E8A-4147-A177-3AD203B41FA5}">
                      <a16:colId xmlns:a16="http://schemas.microsoft.com/office/drawing/2014/main" val="492542991"/>
                    </a:ext>
                  </a:extLst>
                </a:gridCol>
                <a:gridCol w="972062">
                  <a:extLst>
                    <a:ext uri="{9D8B030D-6E8A-4147-A177-3AD203B41FA5}">
                      <a16:colId xmlns:a16="http://schemas.microsoft.com/office/drawing/2014/main" val="2426210405"/>
                    </a:ext>
                  </a:extLst>
                </a:gridCol>
                <a:gridCol w="972062">
                  <a:extLst>
                    <a:ext uri="{9D8B030D-6E8A-4147-A177-3AD203B41FA5}">
                      <a16:colId xmlns:a16="http://schemas.microsoft.com/office/drawing/2014/main" val="2127192741"/>
                    </a:ext>
                  </a:extLst>
                </a:gridCol>
                <a:gridCol w="1231763">
                  <a:extLst>
                    <a:ext uri="{9D8B030D-6E8A-4147-A177-3AD203B41FA5}">
                      <a16:colId xmlns:a16="http://schemas.microsoft.com/office/drawing/2014/main" val="144019834"/>
                    </a:ext>
                  </a:extLst>
                </a:gridCol>
                <a:gridCol w="1231763">
                  <a:extLst>
                    <a:ext uri="{9D8B030D-6E8A-4147-A177-3AD203B41FA5}">
                      <a16:colId xmlns:a16="http://schemas.microsoft.com/office/drawing/2014/main" val="128412631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bg1"/>
                          </a:solidFill>
                        </a:rPr>
                        <a:t>Section</a:t>
                      </a:r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bg1"/>
                          </a:solidFill>
                        </a:rPr>
                        <a:t>Site</a:t>
                      </a:r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bg1"/>
                          </a:solidFill>
                        </a:rPr>
                        <a:t>ICC (3, 5)</a:t>
                      </a:r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bg1"/>
                          </a:solidFill>
                        </a:rPr>
                        <a:t>95% confidence Interval</a:t>
                      </a:r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2045689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measure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 measure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measure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 measure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87704733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GL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5-0.90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6-0.97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577861854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Base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</a:t>
                      </a:r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2-0.91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7-0.98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940560280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8-0.88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3-0.97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684348519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3-0.90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4-0.98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148962245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8-0.82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0-0.96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298242284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6-0.91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9-0.98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107670994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8-0.94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7-0.98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996087178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Mid-ventricle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</a:t>
                      </a:r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2-0.91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8-0.98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896694078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9-0.92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0-0.98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797614470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5-0.90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1-0.97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804263541"/>
                  </a:ext>
                </a:extLst>
              </a:tr>
              <a:tr h="373222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7-0.89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8-0.97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836623503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7-0.70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5-0.92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141762020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8-0.82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0-0.96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363514982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pex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</a:t>
                      </a:r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1-0.84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1-0.96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070681028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2-0.76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1-0.94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334573355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5-0.82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8-0.95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4132005064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7-0.66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3-0.90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6708307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I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6-0.81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4-0.95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896815294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</a:rPr>
                        <a:t>A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5-0.85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7-0.96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21" marB="4572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671363849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5698529-F37A-FDB7-34DE-16BB692DBB63}"/>
              </a:ext>
            </a:extLst>
          </p:cNvPr>
          <p:cNvSpPr txBox="1"/>
          <p:nvPr/>
        </p:nvSpPr>
        <p:spPr>
          <a:xfrm>
            <a:off x="539718" y="9139870"/>
            <a:ext cx="583200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CC, intraclass correlation coefficient; GLS, global longitudinal strain; A, anterior; AS, anteroseptal; IS,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feroseptal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; I, inferior; IL, inferolateral; AL, anterolateral.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5247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50</TotalTime>
  <Words>164</Words>
  <Application>Microsoft Office PowerPoint</Application>
  <PresentationFormat>ワイド画面</PresentationFormat>
  <Paragraphs>10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敏博 鶴田</dc:creator>
  <cp:lastModifiedBy>敏博 鶴田</cp:lastModifiedBy>
  <cp:revision>120</cp:revision>
  <dcterms:created xsi:type="dcterms:W3CDTF">2023-11-30T22:48:51Z</dcterms:created>
  <dcterms:modified xsi:type="dcterms:W3CDTF">2026-02-22T22:43:03Z</dcterms:modified>
</cp:coreProperties>
</file>